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25"/>
  </p:normalViewPr>
  <p:slideViewPr>
    <p:cSldViewPr snapToGrid="0" snapToObjects="1">
      <p:cViewPr varScale="1">
        <p:scale>
          <a:sx n="100" d="100"/>
          <a:sy n="100" d="100"/>
        </p:scale>
        <p:origin x="100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495F1BE-1A1F-B447-8DDC-7AF747C8AA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4623A82-B870-7041-9B30-B66AC5D67E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49F106A-818D-3940-9B0C-60F0CB38A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282BD04-C51A-7845-856D-6322EBF7E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1E5FF19-2101-C841-98A1-2D198B936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284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E63A66-20FB-AA46-8003-3A76699297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942A3C1-FCD6-BE45-B09D-FD5E1F58A3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38C3D84-4A00-1946-AF60-A82094509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5EE3308-6407-D44F-B913-1FD7DFE60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91A00C1-8047-0C4B-8BC5-9D139D631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7790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10866C0-32F7-0445-AF42-AF23ECECBD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67D46C9-6679-624C-9134-448B340E44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B347E41-3EBE-8B46-B0ED-E4488E51E2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925170C-1361-0444-87AF-B4CA235D1F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9622754-58DB-6A43-91C1-E4F176010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5801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F8E85A5-55F1-1743-BD94-E73B538AF1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C5FDAA2-B3E2-AD4E-8DA1-24917A30F1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63C3D17-9974-964E-9033-85DB42F52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401DA6-BD78-E747-AAC5-0A70FB4DF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4573224-55C4-094D-8B27-97BCD337A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8805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D2B26D-D5F5-774A-AE7C-EE8E559BE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13DD439-B496-8B41-A49F-280980341D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B8D7F80-443B-F34A-85D9-3438F4D33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E050985-9CC8-3143-A2ED-6AAB92C6A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77E848E-39C2-0E45-8F9E-C19C8C812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0794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8B68A13-9FF5-FE4F-804E-5E4231A760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33C9E99-195D-2445-ADCC-59DE375175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172EDE2-8C01-5448-972C-2BD2CB14D2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E89F3A5-5365-F043-B1C3-6F0833AC9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7C88E65-B717-AC4B-A260-DD075CFD9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F133422-F74F-F447-9706-F2C0C3213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136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2FA8B2E-E7A9-DD49-9B37-BE2C090A8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BFE5E08-65A8-AC49-BA9E-ECC2525C28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D32E6A7-DEFC-CA40-BF42-3A561F5098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4A5E0AA1-8936-EE40-AD00-6200868353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929B82B1-92BF-0A46-911C-75CA05A2E1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69BAFF42-6E17-D64F-8A34-040E9C9CD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EFB5142A-407C-8A48-ACF4-267FC574B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C6D80668-D3BF-894E-822D-4144F6DF4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9132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0178EA0-E122-274A-9B64-3437028FC7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8D23379-B767-F44A-AB68-FC2BC943E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44489F3-0987-E748-B15E-B26E15F53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863A7F2-B84F-D749-BF6F-4085D33F2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423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2EA2CC7-3E4E-D140-B7A5-5F296C2B4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C0A43301-739C-F344-BDEB-E8047B351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58D381BD-BCEE-3444-B6B7-75CB7F4A5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7449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34BC0A0-3FBC-6449-9A84-BBBD561CA7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EFFD6D5-1DDA-9A42-BD5B-298CA10759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1A03EF4-F43C-BB45-AC9F-D7A824842E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C74DCEE-2774-724C-8AC3-47DC82A5F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35ED1B8-BE48-9E45-863C-B2609C131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B6931E8-187B-FF43-B139-7D88386B9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5023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1932A4B-DBC6-784C-B8D6-C5FB43984D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ACF5333-92D9-784C-BBC6-777BFA6A4F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554A3B4-91F7-F140-9D1F-D1DFC9D82A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AA58554-64D7-0D44-8029-BC9CB3FB0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5D10EE5-D4BB-3748-A763-59131EB12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759E48A-6B8F-DB46-A1AE-E602E3EA5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4698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8BA6E48-72F7-0F46-9B39-F9528DC666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6734500-1774-0F40-A795-9F9BABC24B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F3450E2-7CDE-C14D-A2A9-2B7A06EA82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B560F-19C5-0B4B-A6E4-13EF75F7CB51}" type="datetimeFigureOut">
              <a:rPr lang="es-ES" smtClean="0"/>
              <a:t>1/10/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F780A1B-20C1-E04C-AF5E-757887D3DC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7E35934-89AE-2348-8FFF-CE0A1789F4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426AE-1412-0447-A4CC-FC3AB830FA4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5055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Gráfico, Gráfico de barras&#10;&#10;Descripción generada automáticamente">
            <a:extLst>
              <a:ext uri="{FF2B5EF4-FFF2-40B4-BE49-F238E27FC236}">
                <a16:creationId xmlns:a16="http://schemas.microsoft.com/office/drawing/2014/main" id="{C6DF1E24-AE85-4AA4-83CA-AA61653C0A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253" y="348342"/>
            <a:ext cx="11407663" cy="4736736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FCA5BDE4-E6A0-4A59-AF12-2E8B294CC760}"/>
              </a:ext>
            </a:extLst>
          </p:cNvPr>
          <p:cNvSpPr txBox="1"/>
          <p:nvPr/>
        </p:nvSpPr>
        <p:spPr>
          <a:xfrm>
            <a:off x="430577" y="4893221"/>
            <a:ext cx="396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AEFA7CD-B192-4501-82BD-1866B640FF26}"/>
              </a:ext>
            </a:extLst>
          </p:cNvPr>
          <p:cNvSpPr txBox="1"/>
          <p:nvPr/>
        </p:nvSpPr>
        <p:spPr>
          <a:xfrm>
            <a:off x="399473" y="3986924"/>
            <a:ext cx="396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1E745E7B-D5C8-4A49-A2E1-C8E8C7F95DEB}"/>
              </a:ext>
            </a:extLst>
          </p:cNvPr>
          <p:cNvSpPr txBox="1"/>
          <p:nvPr/>
        </p:nvSpPr>
        <p:spPr>
          <a:xfrm>
            <a:off x="405693" y="3047583"/>
            <a:ext cx="396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15FCEE25-A238-4E25-BE46-5DE34CD0A9CD}"/>
              </a:ext>
            </a:extLst>
          </p:cNvPr>
          <p:cNvSpPr txBox="1"/>
          <p:nvPr/>
        </p:nvSpPr>
        <p:spPr>
          <a:xfrm>
            <a:off x="377933" y="2110701"/>
            <a:ext cx="396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A1A346BC-DDEA-42B0-AB05-E3A7B77F4660}"/>
              </a:ext>
            </a:extLst>
          </p:cNvPr>
          <p:cNvSpPr txBox="1"/>
          <p:nvPr/>
        </p:nvSpPr>
        <p:spPr>
          <a:xfrm rot="16200000">
            <a:off x="-2088634" y="2544600"/>
            <a:ext cx="4673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healthcare worker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B13B1605-8375-4DBF-A909-70D8266C39F3}"/>
              </a:ext>
            </a:extLst>
          </p:cNvPr>
          <p:cNvSpPr txBox="1"/>
          <p:nvPr/>
        </p:nvSpPr>
        <p:spPr>
          <a:xfrm>
            <a:off x="381210" y="1185750"/>
            <a:ext cx="396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730FBA38-355E-4C91-9C91-B67C7F7C3165}"/>
              </a:ext>
            </a:extLst>
          </p:cNvPr>
          <p:cNvSpPr txBox="1"/>
          <p:nvPr/>
        </p:nvSpPr>
        <p:spPr>
          <a:xfrm>
            <a:off x="356393" y="265065"/>
            <a:ext cx="396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381E9913-6EA9-4F14-9B26-F8C273191C0C}"/>
              </a:ext>
            </a:extLst>
          </p:cNvPr>
          <p:cNvSpPr txBox="1"/>
          <p:nvPr/>
        </p:nvSpPr>
        <p:spPr>
          <a:xfrm>
            <a:off x="814743" y="5032196"/>
            <a:ext cx="8364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jor depressive disorder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546C0E19-6200-46C9-9592-0709377EA294}"/>
              </a:ext>
            </a:extLst>
          </p:cNvPr>
          <p:cNvSpPr txBox="1"/>
          <p:nvPr/>
        </p:nvSpPr>
        <p:spPr>
          <a:xfrm>
            <a:off x="1772689" y="5032196"/>
            <a:ext cx="9720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lized anxiety disorder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1B096A6C-3AE1-4CDE-B106-9CDF3BD488B9}"/>
              </a:ext>
            </a:extLst>
          </p:cNvPr>
          <p:cNvSpPr txBox="1"/>
          <p:nvPr/>
        </p:nvSpPr>
        <p:spPr>
          <a:xfrm>
            <a:off x="2948341" y="5029163"/>
            <a:ext cx="7092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ic attacks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9DF1E300-D2AC-45B3-B00A-9889156674FF}"/>
              </a:ext>
            </a:extLst>
          </p:cNvPr>
          <p:cNvSpPr txBox="1"/>
          <p:nvPr/>
        </p:nvSpPr>
        <p:spPr>
          <a:xfrm>
            <a:off x="3912823" y="5029163"/>
            <a:ext cx="79235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-traumatic stress disorder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F5C5A0D4-9A4F-4DCA-9ED5-A891989720A0}"/>
              </a:ext>
            </a:extLst>
          </p:cNvPr>
          <p:cNvSpPr txBox="1"/>
          <p:nvPr/>
        </p:nvSpPr>
        <p:spPr>
          <a:xfrm>
            <a:off x="4950197" y="5035383"/>
            <a:ext cx="8161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Substance us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order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B109D1F7-A745-434F-859F-2D194F38F2B9}"/>
              </a:ext>
            </a:extLst>
          </p:cNvPr>
          <p:cNvSpPr txBox="1"/>
          <p:nvPr/>
        </p:nvSpPr>
        <p:spPr>
          <a:xfrm>
            <a:off x="5978001" y="5029163"/>
            <a:ext cx="8161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y mental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order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22D27929-3ECF-41D8-BAA8-EF65373DCD49}"/>
              </a:ext>
            </a:extLst>
          </p:cNvPr>
          <p:cNvSpPr txBox="1"/>
          <p:nvPr/>
        </p:nvSpPr>
        <p:spPr>
          <a:xfrm>
            <a:off x="7001309" y="5035383"/>
            <a:ext cx="8161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y severe mental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order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D232D8F0-E2DD-4CA5-9AF5-11A9D07C07DE}"/>
              </a:ext>
            </a:extLst>
          </p:cNvPr>
          <p:cNvSpPr txBox="1"/>
          <p:nvPr/>
        </p:nvSpPr>
        <p:spPr>
          <a:xfrm>
            <a:off x="890483" y="3266525"/>
            <a:ext cx="5221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.6%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F82D7E2C-BE48-4645-A4D9-6637B977ABDF}"/>
              </a:ext>
            </a:extLst>
          </p:cNvPr>
          <p:cNvSpPr txBox="1"/>
          <p:nvPr/>
        </p:nvSpPr>
        <p:spPr>
          <a:xfrm>
            <a:off x="1874968" y="3626553"/>
            <a:ext cx="5533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.5%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DCD9E183-9E0A-4BB3-AF33-30768296747E}"/>
              </a:ext>
            </a:extLst>
          </p:cNvPr>
          <p:cNvSpPr txBox="1"/>
          <p:nvPr/>
        </p:nvSpPr>
        <p:spPr>
          <a:xfrm>
            <a:off x="2911143" y="3568354"/>
            <a:ext cx="553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.9%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CFE0D1B5-88BA-4878-ABA1-76CC46AF72EB}"/>
              </a:ext>
            </a:extLst>
          </p:cNvPr>
          <p:cNvSpPr txBox="1"/>
          <p:nvPr/>
        </p:nvSpPr>
        <p:spPr>
          <a:xfrm>
            <a:off x="3955346" y="3556153"/>
            <a:ext cx="53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.2%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4D294909-9BBF-4868-96AF-BCB609A82BFD}"/>
              </a:ext>
            </a:extLst>
          </p:cNvPr>
          <p:cNvSpPr txBox="1"/>
          <p:nvPr/>
        </p:nvSpPr>
        <p:spPr>
          <a:xfrm>
            <a:off x="5003586" y="4579239"/>
            <a:ext cx="451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0%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8B7117C3-F94F-4AB2-9B8D-B6E5FBD1E0AA}"/>
              </a:ext>
            </a:extLst>
          </p:cNvPr>
          <p:cNvSpPr txBox="1"/>
          <p:nvPr/>
        </p:nvSpPr>
        <p:spPr>
          <a:xfrm>
            <a:off x="6017460" y="2442774"/>
            <a:ext cx="5206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.2%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96B20F7F-AD23-47AE-B000-233210FD9DD5}"/>
              </a:ext>
            </a:extLst>
          </p:cNvPr>
          <p:cNvSpPr txBox="1"/>
          <p:nvPr/>
        </p:nvSpPr>
        <p:spPr>
          <a:xfrm>
            <a:off x="7052560" y="4060019"/>
            <a:ext cx="5109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.3%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4457AABA-9FC1-4C0D-B966-E398952FD7A7}"/>
              </a:ext>
            </a:extLst>
          </p:cNvPr>
          <p:cNvSpPr txBox="1"/>
          <p:nvPr/>
        </p:nvSpPr>
        <p:spPr>
          <a:xfrm>
            <a:off x="8066491" y="4459077"/>
            <a:ext cx="5109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9%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CBE3F554-6249-4163-BB48-039C9466D2A5}"/>
              </a:ext>
            </a:extLst>
          </p:cNvPr>
          <p:cNvSpPr txBox="1"/>
          <p:nvPr/>
        </p:nvSpPr>
        <p:spPr>
          <a:xfrm>
            <a:off x="8021656" y="5034563"/>
            <a:ext cx="81611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y suicidal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ought and behavior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603BC294-6414-4C84-977C-92426A326E31}"/>
              </a:ext>
            </a:extLst>
          </p:cNvPr>
          <p:cNvSpPr txBox="1"/>
          <p:nvPr/>
        </p:nvSpPr>
        <p:spPr>
          <a:xfrm>
            <a:off x="9127716" y="4585459"/>
            <a:ext cx="451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0%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1249FEC2-8B6E-42D3-9A57-0B366098C4D4}"/>
              </a:ext>
            </a:extLst>
          </p:cNvPr>
          <p:cNvSpPr txBox="1"/>
          <p:nvPr/>
        </p:nvSpPr>
        <p:spPr>
          <a:xfrm>
            <a:off x="9053274" y="5034563"/>
            <a:ext cx="8161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ssive ideation only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62514959-A231-4151-9B77-CA0004C79B15}"/>
              </a:ext>
            </a:extLst>
          </p:cNvPr>
          <p:cNvSpPr txBox="1"/>
          <p:nvPr/>
        </p:nvSpPr>
        <p:spPr>
          <a:xfrm>
            <a:off x="10065311" y="5032196"/>
            <a:ext cx="81611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e ideation without plan or attempt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45FDFF9D-4526-45C7-A0B2-A3D5479C9855}"/>
              </a:ext>
            </a:extLst>
          </p:cNvPr>
          <p:cNvSpPr txBox="1"/>
          <p:nvPr/>
        </p:nvSpPr>
        <p:spPr>
          <a:xfrm>
            <a:off x="10158511" y="4789465"/>
            <a:ext cx="451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%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4B8E5C18-1B38-4BE0-A9DA-36C53D011353}"/>
              </a:ext>
            </a:extLst>
          </p:cNvPr>
          <p:cNvSpPr txBox="1"/>
          <p:nvPr/>
        </p:nvSpPr>
        <p:spPr>
          <a:xfrm>
            <a:off x="11195525" y="4724033"/>
            <a:ext cx="451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1%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23796A7F-07BE-4971-AC88-CB640D7D53CB}"/>
              </a:ext>
            </a:extLst>
          </p:cNvPr>
          <p:cNvSpPr txBox="1"/>
          <p:nvPr/>
        </p:nvSpPr>
        <p:spPr>
          <a:xfrm>
            <a:off x="11111214" y="5032196"/>
            <a:ext cx="8161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e ideation with plan or attempt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425946D4-C645-4ED4-9C2F-41961085BA70}"/>
              </a:ext>
            </a:extLst>
          </p:cNvPr>
          <p:cNvSpPr txBox="1"/>
          <p:nvPr/>
        </p:nvSpPr>
        <p:spPr>
          <a:xfrm>
            <a:off x="1191214" y="3532826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8.1%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170F1648-3DE7-4154-BFA0-C0320202762F}"/>
              </a:ext>
            </a:extLst>
          </p:cNvPr>
          <p:cNvSpPr txBox="1"/>
          <p:nvPr/>
        </p:nvSpPr>
        <p:spPr>
          <a:xfrm>
            <a:off x="2209813" y="3798650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2.5%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D3A782A1-72A5-47E0-9C80-1DCE7661F467}"/>
              </a:ext>
            </a:extLst>
          </p:cNvPr>
          <p:cNvSpPr txBox="1"/>
          <p:nvPr/>
        </p:nvSpPr>
        <p:spPr>
          <a:xfrm>
            <a:off x="3228413" y="3732211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.0%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C5C4E2A9-EDB1-4F8B-889B-F391A257B146}"/>
              </a:ext>
            </a:extLst>
          </p:cNvPr>
          <p:cNvSpPr txBox="1"/>
          <p:nvPr/>
        </p:nvSpPr>
        <p:spPr>
          <a:xfrm>
            <a:off x="4258441" y="3816757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2.2%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34379BAD-4160-4231-973A-77E1C8294B34}"/>
              </a:ext>
            </a:extLst>
          </p:cNvPr>
          <p:cNvSpPr txBox="1"/>
          <p:nvPr/>
        </p:nvSpPr>
        <p:spPr>
          <a:xfrm>
            <a:off x="5293942" y="4559007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.2%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377B708A-21D8-4974-AE2F-3D8AF9F13F6C}"/>
              </a:ext>
            </a:extLst>
          </p:cNvPr>
          <p:cNvSpPr txBox="1"/>
          <p:nvPr/>
        </p:nvSpPr>
        <p:spPr>
          <a:xfrm>
            <a:off x="6334186" y="2716710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5.7%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CA12BC49-D7DE-4364-98E5-A8DC3B1A4A2C}"/>
              </a:ext>
            </a:extLst>
          </p:cNvPr>
          <p:cNvSpPr txBox="1"/>
          <p:nvPr/>
        </p:nvSpPr>
        <p:spPr>
          <a:xfrm>
            <a:off x="7357790" y="4167741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.5%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0986F7B3-9C02-41E3-AE6E-10DFECAAE5AE}"/>
              </a:ext>
            </a:extLst>
          </p:cNvPr>
          <p:cNvSpPr txBox="1"/>
          <p:nvPr/>
        </p:nvSpPr>
        <p:spPr>
          <a:xfrm>
            <a:off x="8374173" y="4459144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.4%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5D6BB737-A037-4B54-A7D7-892EBC03CBFB}"/>
              </a:ext>
            </a:extLst>
          </p:cNvPr>
          <p:cNvSpPr txBox="1"/>
          <p:nvPr/>
        </p:nvSpPr>
        <p:spPr>
          <a:xfrm>
            <a:off x="9404544" y="4616311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.9%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509EE481-446A-4390-A7C1-19E13F15BE62}"/>
              </a:ext>
            </a:extLst>
          </p:cNvPr>
          <p:cNvSpPr txBox="1"/>
          <p:nvPr/>
        </p:nvSpPr>
        <p:spPr>
          <a:xfrm>
            <a:off x="10431845" y="4801672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8%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E51E5E96-3FC1-4408-82D7-500BB35990F3}"/>
              </a:ext>
            </a:extLst>
          </p:cNvPr>
          <p:cNvSpPr txBox="1"/>
          <p:nvPr/>
        </p:nvSpPr>
        <p:spPr>
          <a:xfrm>
            <a:off x="11455913" y="4693950"/>
            <a:ext cx="459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.7%</a:t>
            </a:r>
          </a:p>
        </p:txBody>
      </p:sp>
      <p:grpSp>
        <p:nvGrpSpPr>
          <p:cNvPr id="54" name="Grupo 53">
            <a:extLst>
              <a:ext uri="{FF2B5EF4-FFF2-40B4-BE49-F238E27FC236}">
                <a16:creationId xmlns:a16="http://schemas.microsoft.com/office/drawing/2014/main" id="{D5BCDD14-E973-49B7-B20F-51382A078BC9}"/>
              </a:ext>
            </a:extLst>
          </p:cNvPr>
          <p:cNvGrpSpPr/>
          <p:nvPr/>
        </p:nvGrpSpPr>
        <p:grpSpPr>
          <a:xfrm>
            <a:off x="1124134" y="3170147"/>
            <a:ext cx="278387" cy="95566"/>
            <a:chOff x="1124134" y="3045741"/>
            <a:chExt cx="278387" cy="95566"/>
          </a:xfrm>
        </p:grpSpPr>
        <p:cxnSp>
          <p:nvCxnSpPr>
            <p:cNvPr id="12" name="Conector recto 11">
              <a:extLst>
                <a:ext uri="{FF2B5EF4-FFF2-40B4-BE49-F238E27FC236}">
                  <a16:creationId xmlns:a16="http://schemas.microsoft.com/office/drawing/2014/main" id="{15AC7F8F-A18D-4B35-9388-F69B090B23F8}"/>
                </a:ext>
              </a:extLst>
            </p:cNvPr>
            <p:cNvCxnSpPr/>
            <p:nvPr/>
          </p:nvCxnSpPr>
          <p:spPr>
            <a:xfrm>
              <a:off x="1132881" y="3047583"/>
              <a:ext cx="2696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Conector recto 48">
              <a:extLst>
                <a:ext uri="{FF2B5EF4-FFF2-40B4-BE49-F238E27FC236}">
                  <a16:creationId xmlns:a16="http://schemas.microsoft.com/office/drawing/2014/main" id="{505DD7DD-949C-490B-9F38-335751E2658A}"/>
                </a:ext>
              </a:extLst>
            </p:cNvPr>
            <p:cNvCxnSpPr>
              <a:cxnSpLocks/>
            </p:cNvCxnSpPr>
            <p:nvPr/>
          </p:nvCxnSpPr>
          <p:spPr>
            <a:xfrm>
              <a:off x="1124134" y="3045741"/>
              <a:ext cx="0" cy="8852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Conector recto 51">
              <a:extLst>
                <a:ext uri="{FF2B5EF4-FFF2-40B4-BE49-F238E27FC236}">
                  <a16:creationId xmlns:a16="http://schemas.microsoft.com/office/drawing/2014/main" id="{7397F6E3-4650-473D-957C-44D0BEDCC99F}"/>
                </a:ext>
              </a:extLst>
            </p:cNvPr>
            <p:cNvCxnSpPr>
              <a:cxnSpLocks/>
            </p:cNvCxnSpPr>
            <p:nvPr/>
          </p:nvCxnSpPr>
          <p:spPr>
            <a:xfrm>
              <a:off x="1400936" y="3052786"/>
              <a:ext cx="0" cy="8852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5" name="CuadroTexto 54">
            <a:extLst>
              <a:ext uri="{FF2B5EF4-FFF2-40B4-BE49-F238E27FC236}">
                <a16:creationId xmlns:a16="http://schemas.microsoft.com/office/drawing/2014/main" id="{3CEE7C3E-4F38-4ED3-A33D-310674ABCAD6}"/>
              </a:ext>
            </a:extLst>
          </p:cNvPr>
          <p:cNvSpPr txBox="1"/>
          <p:nvPr/>
        </p:nvSpPr>
        <p:spPr>
          <a:xfrm>
            <a:off x="992775" y="2948838"/>
            <a:ext cx="6177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01</a:t>
            </a:r>
          </a:p>
        </p:txBody>
      </p:sp>
      <p:cxnSp>
        <p:nvCxnSpPr>
          <p:cNvPr id="57" name="Conector recto 56">
            <a:extLst>
              <a:ext uri="{FF2B5EF4-FFF2-40B4-BE49-F238E27FC236}">
                <a16:creationId xmlns:a16="http://schemas.microsoft.com/office/drawing/2014/main" id="{3CDCDF4E-1AC6-4C1F-8630-7172C04377F2}"/>
              </a:ext>
            </a:extLst>
          </p:cNvPr>
          <p:cNvCxnSpPr/>
          <p:nvPr/>
        </p:nvCxnSpPr>
        <p:spPr>
          <a:xfrm>
            <a:off x="4208871" y="3380375"/>
            <a:ext cx="269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Conector recto 57">
            <a:extLst>
              <a:ext uri="{FF2B5EF4-FFF2-40B4-BE49-F238E27FC236}">
                <a16:creationId xmlns:a16="http://schemas.microsoft.com/office/drawing/2014/main" id="{DF7F2604-F668-4657-8D91-859F2ABD7964}"/>
              </a:ext>
            </a:extLst>
          </p:cNvPr>
          <p:cNvCxnSpPr>
            <a:cxnSpLocks/>
          </p:cNvCxnSpPr>
          <p:nvPr/>
        </p:nvCxnSpPr>
        <p:spPr>
          <a:xfrm>
            <a:off x="4206344" y="3378533"/>
            <a:ext cx="0" cy="88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Conector recto 58">
            <a:extLst>
              <a:ext uri="{FF2B5EF4-FFF2-40B4-BE49-F238E27FC236}">
                <a16:creationId xmlns:a16="http://schemas.microsoft.com/office/drawing/2014/main" id="{C03F4C0C-2123-49CB-B0C3-1E9A1A12143C}"/>
              </a:ext>
            </a:extLst>
          </p:cNvPr>
          <p:cNvCxnSpPr>
            <a:cxnSpLocks/>
          </p:cNvCxnSpPr>
          <p:nvPr/>
        </p:nvCxnSpPr>
        <p:spPr>
          <a:xfrm>
            <a:off x="4483146" y="3379358"/>
            <a:ext cx="0" cy="88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CuadroTexto 59">
            <a:extLst>
              <a:ext uri="{FF2B5EF4-FFF2-40B4-BE49-F238E27FC236}">
                <a16:creationId xmlns:a16="http://schemas.microsoft.com/office/drawing/2014/main" id="{972B0165-7A51-433D-98D9-1BDEA14BB123}"/>
              </a:ext>
            </a:extLst>
          </p:cNvPr>
          <p:cNvSpPr txBox="1"/>
          <p:nvPr/>
        </p:nvSpPr>
        <p:spPr>
          <a:xfrm>
            <a:off x="4074985" y="3157224"/>
            <a:ext cx="6177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01</a:t>
            </a:r>
          </a:p>
        </p:txBody>
      </p:sp>
      <p:cxnSp>
        <p:nvCxnSpPr>
          <p:cNvPr id="62" name="Conector recto 61">
            <a:extLst>
              <a:ext uri="{FF2B5EF4-FFF2-40B4-BE49-F238E27FC236}">
                <a16:creationId xmlns:a16="http://schemas.microsoft.com/office/drawing/2014/main" id="{245C9CCA-85D7-43FE-9C05-5F43123A8440}"/>
              </a:ext>
            </a:extLst>
          </p:cNvPr>
          <p:cNvCxnSpPr/>
          <p:nvPr/>
        </p:nvCxnSpPr>
        <p:spPr>
          <a:xfrm>
            <a:off x="6255383" y="2316685"/>
            <a:ext cx="269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Conector recto 62">
            <a:extLst>
              <a:ext uri="{FF2B5EF4-FFF2-40B4-BE49-F238E27FC236}">
                <a16:creationId xmlns:a16="http://schemas.microsoft.com/office/drawing/2014/main" id="{40D8448C-758B-4C0D-867C-1CDC437DC50A}"/>
              </a:ext>
            </a:extLst>
          </p:cNvPr>
          <p:cNvCxnSpPr>
            <a:cxnSpLocks/>
          </p:cNvCxnSpPr>
          <p:nvPr/>
        </p:nvCxnSpPr>
        <p:spPr>
          <a:xfrm>
            <a:off x="6252856" y="2314843"/>
            <a:ext cx="0" cy="88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Conector recto 63">
            <a:extLst>
              <a:ext uri="{FF2B5EF4-FFF2-40B4-BE49-F238E27FC236}">
                <a16:creationId xmlns:a16="http://schemas.microsoft.com/office/drawing/2014/main" id="{0FECC59A-88A6-4CDA-8814-6840574EB4DB}"/>
              </a:ext>
            </a:extLst>
          </p:cNvPr>
          <p:cNvCxnSpPr>
            <a:cxnSpLocks/>
          </p:cNvCxnSpPr>
          <p:nvPr/>
        </p:nvCxnSpPr>
        <p:spPr>
          <a:xfrm>
            <a:off x="6529658" y="2321888"/>
            <a:ext cx="0" cy="88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CuadroTexto 64">
            <a:extLst>
              <a:ext uri="{FF2B5EF4-FFF2-40B4-BE49-F238E27FC236}">
                <a16:creationId xmlns:a16="http://schemas.microsoft.com/office/drawing/2014/main" id="{D15F63D0-43FA-4651-9E1A-2768549BDCD4}"/>
              </a:ext>
            </a:extLst>
          </p:cNvPr>
          <p:cNvSpPr txBox="1"/>
          <p:nvPr/>
        </p:nvSpPr>
        <p:spPr>
          <a:xfrm>
            <a:off x="6121497" y="2093534"/>
            <a:ext cx="6177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03</a:t>
            </a:r>
          </a:p>
        </p:txBody>
      </p:sp>
      <p:sp>
        <p:nvSpPr>
          <p:cNvPr id="71" name="Rectángulo 70">
            <a:extLst>
              <a:ext uri="{FF2B5EF4-FFF2-40B4-BE49-F238E27FC236}">
                <a16:creationId xmlns:a16="http://schemas.microsoft.com/office/drawing/2014/main" id="{2D497F21-79DE-44C7-BF73-E75C479E465D}"/>
              </a:ext>
            </a:extLst>
          </p:cNvPr>
          <p:cNvSpPr/>
          <p:nvPr/>
        </p:nvSpPr>
        <p:spPr>
          <a:xfrm>
            <a:off x="8834107" y="511286"/>
            <a:ext cx="72000" cy="72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2" name="CuadroTexto 71">
            <a:extLst>
              <a:ext uri="{FF2B5EF4-FFF2-40B4-BE49-F238E27FC236}">
                <a16:creationId xmlns:a16="http://schemas.microsoft.com/office/drawing/2014/main" id="{C3B79B7D-3AA4-41AE-95EB-168867ACB831}"/>
              </a:ext>
            </a:extLst>
          </p:cNvPr>
          <p:cNvSpPr txBox="1"/>
          <p:nvPr/>
        </p:nvSpPr>
        <p:spPr>
          <a:xfrm>
            <a:off x="8842986" y="414684"/>
            <a:ext cx="13398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spital 12 Octubre</a:t>
            </a:r>
          </a:p>
        </p:txBody>
      </p:sp>
      <p:sp>
        <p:nvSpPr>
          <p:cNvPr id="73" name="Rectángulo 72">
            <a:extLst>
              <a:ext uri="{FF2B5EF4-FFF2-40B4-BE49-F238E27FC236}">
                <a16:creationId xmlns:a16="http://schemas.microsoft.com/office/drawing/2014/main" id="{7DB72C3B-792E-43D4-946F-9173B25C2F04}"/>
              </a:ext>
            </a:extLst>
          </p:cNvPr>
          <p:cNvSpPr/>
          <p:nvPr/>
        </p:nvSpPr>
        <p:spPr>
          <a:xfrm>
            <a:off x="8830998" y="725891"/>
            <a:ext cx="72000" cy="72000"/>
          </a:xfrm>
          <a:prstGeom prst="rect">
            <a:avLst/>
          </a:prstGeom>
          <a:solidFill>
            <a:srgbClr val="A6A6A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5C0E71E8-9D50-4F56-8424-9812E5FCCB8B}"/>
              </a:ext>
            </a:extLst>
          </p:cNvPr>
          <p:cNvSpPr txBox="1"/>
          <p:nvPr/>
        </p:nvSpPr>
        <p:spPr>
          <a:xfrm>
            <a:off x="8864763" y="623069"/>
            <a:ext cx="19276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tionwide MINDCOVID study</a:t>
            </a:r>
          </a:p>
        </p:txBody>
      </p:sp>
    </p:spTree>
    <p:extLst>
      <p:ext uri="{BB962C8B-B14F-4D97-AF65-F5344CB8AC3E}">
        <p14:creationId xmlns:p14="http://schemas.microsoft.com/office/powerpoint/2010/main" val="3041638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id="{3322F836-A788-D448-999C-E52A5B6475BB}"/>
              </a:ext>
            </a:extLst>
          </p:cNvPr>
          <p:cNvSpPr/>
          <p:nvPr/>
        </p:nvSpPr>
        <p:spPr>
          <a:xfrm>
            <a:off x="645114" y="1110319"/>
            <a:ext cx="1122938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u="sng" dirty="0" err="1"/>
              <a:t>Title</a:t>
            </a:r>
            <a:r>
              <a:rPr lang="es-ES" dirty="0"/>
              <a:t>: </a:t>
            </a:r>
            <a:r>
              <a:rPr lang="es-ES" dirty="0" err="1"/>
              <a:t>Comparison</a:t>
            </a:r>
            <a:r>
              <a:rPr lang="es-ES" dirty="0"/>
              <a:t> </a:t>
            </a:r>
            <a:r>
              <a:rPr lang="es-ES" dirty="0" err="1"/>
              <a:t>between</a:t>
            </a:r>
            <a:r>
              <a:rPr lang="es-ES" dirty="0"/>
              <a:t> </a:t>
            </a:r>
            <a:r>
              <a:rPr lang="en-US" dirty="0">
                <a:latin typeface="Times New Roman" panose="02020603050405020304" pitchFamily="18" charset="0"/>
              </a:rPr>
              <a:t>p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revalence rates of probable mental disorder </a:t>
            </a:r>
            <a:r>
              <a:rPr lang="es-ES" dirty="0" err="1"/>
              <a:t>with</a:t>
            </a:r>
            <a:r>
              <a:rPr lang="es-ES" dirty="0"/>
              <a:t> </a:t>
            </a:r>
            <a:r>
              <a:rPr lang="es-ES" dirty="0" err="1"/>
              <a:t>national</a:t>
            </a:r>
            <a:r>
              <a:rPr lang="es-ES" dirty="0"/>
              <a:t> data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endParaRPr lang="en-US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n-US" u="sng" dirty="0"/>
              <a:t>Legend</a:t>
            </a:r>
            <a:r>
              <a:rPr lang="en-US" dirty="0"/>
              <a:t>: Comparing our present results,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in </a:t>
            </a:r>
            <a:r>
              <a:rPr lang="en-US" dirty="0"/>
              <a:t>Hospital 12 de </a:t>
            </a:r>
            <a:r>
              <a:rPr lang="en-US" dirty="0" err="1"/>
              <a:t>Octubre</a:t>
            </a:r>
            <a:r>
              <a:rPr lang="en-US" dirty="0"/>
              <a:t>, with those from the multicenter, nationwide MINDCOVID study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20042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45</Words>
  <Application>Microsoft Macintosh PowerPoint</Application>
  <PresentationFormat>Panorámica</PresentationFormat>
  <Paragraphs>51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rene Rodrigo Holgado</dc:creator>
  <cp:lastModifiedBy>Irene Rodrigo Holgado</cp:lastModifiedBy>
  <cp:revision>2</cp:revision>
  <dcterms:created xsi:type="dcterms:W3CDTF">2023-10-01T16:13:58Z</dcterms:created>
  <dcterms:modified xsi:type="dcterms:W3CDTF">2023-10-01T16:28:28Z</dcterms:modified>
</cp:coreProperties>
</file>